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6" r:id="rId2"/>
    <p:sldId id="268" r:id="rId3"/>
    <p:sldId id="272" r:id="rId4"/>
    <p:sldId id="270" r:id="rId5"/>
    <p:sldId id="259" r:id="rId6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ziz, Mina" initials="AM" lastIdx="1" clrIdx="0">
    <p:extLst>
      <p:ext uri="{19B8F6BF-5375-455C-9EA6-DF929625EA0E}">
        <p15:presenceInfo xmlns:p15="http://schemas.microsoft.com/office/powerpoint/2012/main" userId="S-1-5-21-3676313182-2055043702-2189418671-24333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60"/>
  </p:normalViewPr>
  <p:slideViewPr>
    <p:cSldViewPr>
      <p:cViewPr varScale="1">
        <p:scale>
          <a:sx n="52" d="100"/>
          <a:sy n="52" d="100"/>
        </p:scale>
        <p:origin x="2068" y="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632610-0EE3-4C87-B331-238B5F839038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4E5890-F393-43C8-9CC8-F5E88B2930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6630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4E5890-F393-43C8-9CC8-F5E88B2930F3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38635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F:\lsp\lsp 文章准备\准备发表\高芥酸的脂质分布\1.FAE1-paper - WY20, WH3401\Sfig 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720" y="539552"/>
            <a:ext cx="5076000" cy="50360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3"/>
          <p:cNvSpPr txBox="1"/>
          <p:nvPr/>
        </p:nvSpPr>
        <p:spPr>
          <a:xfrm>
            <a:off x="908720" y="5791673"/>
            <a:ext cx="547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atial distribution of selected TAG species in mature seeds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38050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>
            <a:extLst>
              <a:ext uri="{FF2B5EF4-FFF2-40B4-BE49-F238E27FC236}">
                <a16:creationId xmlns:a16="http://schemas.microsoft.com/office/drawing/2014/main" id="{501B9355-BAAE-41DC-A9ED-A31585693A78}"/>
              </a:ext>
            </a:extLst>
          </p:cNvPr>
          <p:cNvSpPr txBox="1"/>
          <p:nvPr/>
        </p:nvSpPr>
        <p:spPr>
          <a:xfrm>
            <a:off x="1052736" y="5364089"/>
            <a:ext cx="48245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atial distribution of selected PC species in mature seeds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 descr="C:\Users\Administrator\Desktop\FigS2-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8760" y="755576"/>
            <a:ext cx="4104000" cy="44371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505798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F:\lsp\lsp 文章准备\准备发表\高芥酸的脂质分布\1.FAE1-paper - WY20, WH3401\SFig-4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648" y="683568"/>
            <a:ext cx="6264000" cy="5593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81360" y="6444208"/>
            <a:ext cx="6156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ure S3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hree biological replicates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of spatial distribution of selected TAG and PC species containing fatty acid with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more than 18 carbons in WH3401.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90633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"/>
          <p:cNvSpPr txBox="1"/>
          <p:nvPr/>
        </p:nvSpPr>
        <p:spPr>
          <a:xfrm>
            <a:off x="297336" y="5724128"/>
            <a:ext cx="6156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S4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nalysis of FAE1s in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altLang="zh-CN" sz="1200" i="1" dirty="0" err="1" smtClean="0">
                <a:latin typeface="Times New Roman" pitchFamily="18" charset="0"/>
                <a:cs typeface="Times New Roman" pitchFamily="18" charset="0"/>
              </a:rPr>
              <a:t>napus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) Phylogenic analysis of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AE1s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) The structure analysis of FAE1 protein using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Pfam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software online.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 descr="F:\lsp\lsp 文章准备\准备发表\高芥酸的脂质分布\1.FAE1-paper - WY20, WH3401\SFig3-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336" y="395536"/>
            <a:ext cx="6156000" cy="52008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041256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Administrator\Desktop\S table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720" y="633577"/>
            <a:ext cx="5076000" cy="30748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矩形 1"/>
          <p:cNvSpPr>
            <a:spLocks noChangeArrowheads="1"/>
          </p:cNvSpPr>
          <p:nvPr/>
        </p:nvSpPr>
        <p:spPr bwMode="auto">
          <a:xfrm>
            <a:off x="821854" y="373425"/>
            <a:ext cx="417646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Table S1. 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Primers used for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-PCR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1910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06</TotalTime>
  <Words>94</Words>
  <Application>Microsoft Office PowerPoint</Application>
  <PresentationFormat>全屏显示(4:3)</PresentationFormat>
  <Paragraphs>6</Paragraphs>
  <Slides>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等线</vt:lpstr>
      <vt:lpstr>宋体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Liang Guo</cp:lastModifiedBy>
  <cp:revision>92</cp:revision>
  <dcterms:created xsi:type="dcterms:W3CDTF">2019-06-30T23:23:29Z</dcterms:created>
  <dcterms:modified xsi:type="dcterms:W3CDTF">2019-10-18T07:49:34Z</dcterms:modified>
</cp:coreProperties>
</file>